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D1C3C-EA30-4F00-B319-9DDBE3C6356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821246-CCF5-4F4B-B8E4-A42E47AFFF4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41834-E375-4EE6-A26E-018B1B11DB8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24AEF6-9D37-45F0-9755-EC0E0923B8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482A8B-661D-40DC-BF32-918D68AC81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1EC497-6A76-4C1E-B4F3-13AFD8D800D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EBC71-1E44-44CF-B969-3B42D46756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4F1FBB-A8D1-4259-8386-E5A6E946EF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DDB54E-5BEC-4F50-81E5-AC881BC9D3A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B73A67-2DA7-4B93-89B4-5E98EA5472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E40C69-27D6-4E18-8055-A058125AC9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489CCE-223D-4762-8690-E508A80F07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D77C6A0-8052-479D-AFC7-B639A607B1E9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8600" y="838080"/>
            <a:ext cx="8726400" cy="415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</a:rPr>
              <a:t>Additional files 1: Organisation and environment of Lbx-Tlx loci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Genes or gene groups appearing at tetrapod as well as fish loci are represented by coloured boxe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(Note: due to the limitations of the colour palette, paralogous genes at the four different loci are not 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necessarily highlighted with the same colour)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The chromosomal localisation of genes/gene groups is indicated with the species name on the left, if all 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genes are physically linked. For genes on different or unlinked DNA fragments, the scaffold or contig is 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indicated within the table. Localisation of genes on a given chromosome or scaffold is indicated in Mb.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Abbreviations of species names – see list of abbreviations, supplementary material 2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"/>
          <p:cNvSpPr/>
          <p:nvPr/>
        </p:nvSpPr>
        <p:spPr>
          <a:xfrm>
            <a:off x="152280" y="0"/>
            <a:ext cx="1067040" cy="742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5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5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Lbx1-Tlx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lnSpc>
                <a:spcPct val="5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loc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3" name="suppl%201a%20Lbx1%20loci" descr=""/>
          <p:cNvPicPr/>
          <p:nvPr/>
        </p:nvPicPr>
        <p:blipFill>
          <a:blip r:embed="rId1"/>
          <a:stretch/>
        </p:blipFill>
        <p:spPr>
          <a:xfrm>
            <a:off x="1295280" y="196920"/>
            <a:ext cx="7391520" cy="65214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"/>
          <p:cNvSpPr/>
          <p:nvPr/>
        </p:nvSpPr>
        <p:spPr>
          <a:xfrm>
            <a:off x="152280" y="304920"/>
            <a:ext cx="2667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ormer Lbx4-Tlx4 loc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5" name="suppl%201b%20Lbx4%20loci" descr=""/>
          <p:cNvPicPr/>
          <p:nvPr/>
        </p:nvPicPr>
        <p:blipFill>
          <a:blip r:embed="rId1"/>
          <a:stretch/>
        </p:blipFill>
        <p:spPr>
          <a:xfrm>
            <a:off x="228600" y="762120"/>
            <a:ext cx="8686800" cy="5761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"/>
          <p:cNvSpPr/>
          <p:nvPr/>
        </p:nvSpPr>
        <p:spPr>
          <a:xfrm>
            <a:off x="304920" y="304920"/>
            <a:ext cx="3962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Lbx3)-Tlx3 loc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7" name="suppl%201d%20Tlx3%20loci" descr=""/>
          <p:cNvPicPr/>
          <p:nvPr/>
        </p:nvPicPr>
        <p:blipFill>
          <a:blip r:embed="rId1"/>
          <a:stretch/>
        </p:blipFill>
        <p:spPr>
          <a:xfrm>
            <a:off x="304920" y="685800"/>
            <a:ext cx="8421480" cy="5824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152280" y="152280"/>
            <a:ext cx="1524240" cy="63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Nkx3.2 and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Lbx2-Tlx2 loci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9" name="suppl%201c%20Lbx2%20loci" descr=""/>
          <p:cNvPicPr/>
          <p:nvPr/>
        </p:nvPicPr>
        <p:blipFill>
          <a:blip r:embed="rId1"/>
          <a:stretch/>
        </p:blipFill>
        <p:spPr>
          <a:xfrm>
            <a:off x="1981080" y="152280"/>
            <a:ext cx="6400800" cy="65534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2-06T13:28:27Z</dcterms:created>
  <dc:creator> susanne dietrich</dc:creator>
  <dc:description/>
  <dc:language>en-US</dc:language>
  <cp:lastModifiedBy> susanne dietrich</cp:lastModifiedBy>
  <dcterms:modified xsi:type="dcterms:W3CDTF">2007-12-13T19:24:10Z</dcterms:modified>
  <cp:revision>7</cp:revision>
  <dc:subject/>
  <dc:title>PowerPoint Presentation</dc:title>
</cp:coreProperties>
</file>